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77" r:id="rId2"/>
    <p:sldId id="275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60"/>
    <p:restoredTop sz="94663"/>
  </p:normalViewPr>
  <p:slideViewPr>
    <p:cSldViewPr snapToGrid="0" snapToObjects="1">
      <p:cViewPr varScale="1">
        <p:scale>
          <a:sx n="88" d="100"/>
          <a:sy n="88" d="100"/>
        </p:scale>
        <p:origin x="31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9A0FC3-42F2-EB4A-8229-DAD73338DDCF}" type="datetimeFigureOut">
              <a:rPr lang="en-US" smtClean="0"/>
              <a:t>2/15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ECE6D7-4886-2643-A48B-18010850CE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982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291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55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001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138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809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92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526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3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67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534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234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B7948-9D78-0443-B337-01C022397CE2}" type="datetimeFigureOut">
              <a:rPr lang="en-US" smtClean="0"/>
              <a:t>2/15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79E3D2-C37A-B441-B962-37599A033A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382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29CA480-96E7-FC4E-A355-89B15B8E42E3}"/>
              </a:ext>
            </a:extLst>
          </p:cNvPr>
          <p:cNvSpPr/>
          <p:nvPr/>
        </p:nvSpPr>
        <p:spPr>
          <a:xfrm>
            <a:off x="0" y="998464"/>
            <a:ext cx="6858000" cy="34180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ose-Escalating Toxicology of the Candidate Biologic ELP-VEGF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mariu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. Waller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Stephen P. Burke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Jason Engel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Alejandro R. Chade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,4,5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Gene L. Bidwell, III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,2,6,*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Pharmacology and Toxic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Neur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Physiology and Biophysics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Medicine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5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Radi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partment of Cell and Molecular Biology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University of Mississippi Medical Center, 2500 North State Street, Jackson, MS. 39216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82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75816BC-6FAA-1641-8D04-292B3C7DC0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044027"/>
              </p:ext>
            </p:extLst>
          </p:nvPr>
        </p:nvGraphicFramePr>
        <p:xfrm>
          <a:off x="320657" y="301388"/>
          <a:ext cx="6217922" cy="330447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729301">
                  <a:extLst>
                    <a:ext uri="{9D8B030D-6E8A-4147-A177-3AD203B41FA5}">
                      <a16:colId xmlns:a16="http://schemas.microsoft.com/office/drawing/2014/main" val="2404287872"/>
                    </a:ext>
                  </a:extLst>
                </a:gridCol>
                <a:gridCol w="961923">
                  <a:extLst>
                    <a:ext uri="{9D8B030D-6E8A-4147-A177-3AD203B41FA5}">
                      <a16:colId xmlns:a16="http://schemas.microsoft.com/office/drawing/2014/main" val="3606083137"/>
                    </a:ext>
                  </a:extLst>
                </a:gridCol>
                <a:gridCol w="961923">
                  <a:extLst>
                    <a:ext uri="{9D8B030D-6E8A-4147-A177-3AD203B41FA5}">
                      <a16:colId xmlns:a16="http://schemas.microsoft.com/office/drawing/2014/main" val="2281690317"/>
                    </a:ext>
                  </a:extLst>
                </a:gridCol>
                <a:gridCol w="905340">
                  <a:extLst>
                    <a:ext uri="{9D8B030D-6E8A-4147-A177-3AD203B41FA5}">
                      <a16:colId xmlns:a16="http://schemas.microsoft.com/office/drawing/2014/main" val="2468166147"/>
                    </a:ext>
                  </a:extLst>
                </a:gridCol>
                <a:gridCol w="905340">
                  <a:extLst>
                    <a:ext uri="{9D8B030D-6E8A-4147-A177-3AD203B41FA5}">
                      <a16:colId xmlns:a16="http://schemas.microsoft.com/office/drawing/2014/main" val="1422556592"/>
                    </a:ext>
                  </a:extLst>
                </a:gridCol>
                <a:gridCol w="905340">
                  <a:extLst>
                    <a:ext uri="{9D8B030D-6E8A-4147-A177-3AD203B41FA5}">
                      <a16:colId xmlns:a16="http://schemas.microsoft.com/office/drawing/2014/main" val="3785685514"/>
                    </a:ext>
                  </a:extLst>
                </a:gridCol>
                <a:gridCol w="848755">
                  <a:extLst>
                    <a:ext uri="{9D8B030D-6E8A-4147-A177-3AD203B41FA5}">
                      <a16:colId xmlns:a16="http://schemas.microsoft.com/office/drawing/2014/main" val="1488085730"/>
                    </a:ext>
                  </a:extLst>
                </a:gridCol>
              </a:tblGrid>
              <a:tr h="367164">
                <a:tc>
                  <a:txBody>
                    <a:bodyPr/>
                    <a:lstStyle/>
                    <a:p>
                      <a:endParaRPr lang="en-US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Salin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1 mg/kg ELP-VEG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 mg/kg 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LP-VEG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0 mg/kg 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ELP-VEG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00 mg/kg ELP-VEG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00 mg/kg ELP-VEG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587824945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lbumin </a:t>
                      </a:r>
                      <a:endParaRPr lang="en-US" sz="11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g/d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.14 ± 0.9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.37 ± 1.1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.18 ± 1.0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.14 ± 1.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.00 ± 0.5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2.87 ± 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1449645355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ST </a:t>
                      </a:r>
                      <a:endParaRPr lang="en-US" sz="11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U/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65.29 ± 12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95.33 ± 15.82*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65.20 ± 14.8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4.00 ± 14.8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66.33 ± 8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62.67 ± 8.3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85961499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ALT  </a:t>
                      </a:r>
                      <a:endParaRPr lang="en-US" sz="11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U/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5.43 ± 5.1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2.67 ± 2.5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4.40 ± 8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3.20 ± 7.6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40.00 ± 7.2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34.33 ± 5.5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2622026214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BUN </a:t>
                      </a:r>
                      <a:endParaRPr lang="en-US" sz="11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(mg/d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7.71 ± 3.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2.33 ± 8.1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9.20 ± 3.5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3.60 ± 9.8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8.67 ± 0.5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5.67 ± 2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388925098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Creatinine (mg/d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37 ± 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42 ± 0.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37 ± 0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37 ± 0.0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43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41 ± 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74765194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GGT </a:t>
                      </a:r>
                      <a:r>
                        <a:rPr lang="en-US" sz="800" baseline="30000" dirty="0">
                          <a:effectLst/>
                        </a:rPr>
                        <a:t>☨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U/L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.00 ± 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.00 ± 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.00 ± 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.00 ± 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.00 ± 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7.00 ± 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136283390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LDH 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U/L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76.00 ± 130.8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48.67 ± 150.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01.80 ± 28.5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40.00 ± 67.4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129.00 ± 36.5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81.33 ± 10.7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3826105354"/>
                  </a:ext>
                </a:extLst>
              </a:tr>
              <a:tr h="36716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TBILI 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(mg/dL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22 ± 0.1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36 ± 0.3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19 ± 0.0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15 ± 0.0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0.22 ± 0.0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23 ± 0.0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533" marR="90533" marT="45268" marB="45268"/>
                </a:tc>
                <a:extLst>
                  <a:ext uri="{0D108BD9-81ED-4DB2-BD59-A6C34878D82A}">
                    <a16:rowId xmlns:a16="http://schemas.microsoft.com/office/drawing/2014/main" val="2774163327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8DD6DF67-6707-BF4F-A585-6DD8413DD96B}"/>
              </a:ext>
            </a:extLst>
          </p:cNvPr>
          <p:cNvSpPr/>
          <p:nvPr/>
        </p:nvSpPr>
        <p:spPr>
          <a:xfrm>
            <a:off x="291638" y="3735581"/>
            <a:ext cx="624694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ally significant difference from Saline, p &lt; 0.05, one-way ANOVA with post-hoc Dunnett correction for multiple comparisons</a:t>
            </a:r>
          </a:p>
          <a:p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☨  GGT levels were at the lower detectable limit for all sample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E7670E8-4C9C-0945-A7CE-9E301208EC17}"/>
              </a:ext>
            </a:extLst>
          </p:cNvPr>
          <p:cNvSpPr/>
          <p:nvPr/>
        </p:nvSpPr>
        <p:spPr>
          <a:xfrm>
            <a:off x="291638" y="4655005"/>
            <a:ext cx="5973059" cy="16619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1. 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lasma Markers of Renal and Liver Function. Plasma samples collected on Day 14 after ELP-VEGF injection were assessed for markers of renal and hepatic function and injury using a Vet AXCEL chemistry analyzer.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[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spartate Transaminase (AST), Alanine Transaminase (ALT), Blood Urea Nitrogen (BUN, Gamma-Glutamyl Transferase (GGT), Lactate Dehydrogenase (LDH), Total Bilirubin (TBILI)]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699172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483</TotalTime>
  <Words>405</Words>
  <Application>Microsoft Macintosh PowerPoint</Application>
  <PresentationFormat>Letter Paper (8.5x11 in)</PresentationFormat>
  <Paragraphs>8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e Bidwell</dc:creator>
  <cp:lastModifiedBy>Jamarius Waller</cp:lastModifiedBy>
  <cp:revision>93</cp:revision>
  <dcterms:created xsi:type="dcterms:W3CDTF">2020-03-17T18:04:13Z</dcterms:created>
  <dcterms:modified xsi:type="dcterms:W3CDTF">2021-02-15T15:04:21Z</dcterms:modified>
</cp:coreProperties>
</file>